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5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6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9FA839C-C4F9-4715-90C9-8F3CC44F46C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Undertitel 2">
            <a:extLst>
              <a:ext uri="{FF2B5EF4-FFF2-40B4-BE49-F238E27FC236}">
                <a16:creationId xmlns:a16="http://schemas.microsoft.com/office/drawing/2014/main" id="{DF54B013-1A1A-493D-9076-63CDA1F8C4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/>
              <a:t>Klik for at redigere undertiteltypografien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3274141E-AB63-4D85-8C74-96B3B237E5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8BD4B-DD93-4BBA-90B8-A2EDFD22F519}" type="datetimeFigureOut">
              <a:rPr lang="da-DK" smtClean="0"/>
              <a:t>08-09-2022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D3CA3F76-765E-483D-AA6A-8DBBBB8FA1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290D0756-FBB5-4537-9720-BA0CCAF69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58537B-85A7-45F3-B6A5-2825FFF8283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67028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0F61977-A8A3-4BD4-80A6-EFDADE8DB4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8B4EFD1F-C5EA-48CE-B697-934C96A529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E136E733-ACC4-45AE-A143-21CD4E63DD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8BD4B-DD93-4BBA-90B8-A2EDFD22F519}" type="datetimeFigureOut">
              <a:rPr lang="da-DK" smtClean="0"/>
              <a:t>08-09-2022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953C363E-B053-4D2D-8CAD-F49A3BC898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2C13E66E-5795-42CC-A182-20DF3449B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58537B-85A7-45F3-B6A5-2825FFF8283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8152371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>
            <a:extLst>
              <a:ext uri="{FF2B5EF4-FFF2-40B4-BE49-F238E27FC236}">
                <a16:creationId xmlns:a16="http://schemas.microsoft.com/office/drawing/2014/main" id="{877F9EBF-3E81-4947-B1CF-09604332B3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9021CC94-C715-4A1E-B757-C2D258F897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9CCC2210-0323-4D68-8E37-8C053E6CB5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8BD4B-DD93-4BBA-90B8-A2EDFD22F519}" type="datetimeFigureOut">
              <a:rPr lang="da-DK" smtClean="0"/>
              <a:t>08-09-2022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36DABE83-1F63-4A7E-AD1D-EB3C743CE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072D09F1-8A63-4C43-8E5E-58192D74DC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58537B-85A7-45F3-B6A5-2825FFF8283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657660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805E46A-462C-47CD-BCA9-445021E186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DFB63B06-57C7-43FE-A6C6-2A59B91A21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AD6C1916-79CE-4745-96A5-2EF4D7DA9D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8BD4B-DD93-4BBA-90B8-A2EDFD22F519}" type="datetimeFigureOut">
              <a:rPr lang="da-DK" smtClean="0"/>
              <a:t>08-09-2022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DFF595FC-C160-40CE-B294-62793E3103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75784524-D465-4C64-91DD-CAB8C09DA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58537B-85A7-45F3-B6A5-2825FFF8283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0990307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19A4400-FF30-4A18-BCA7-58387388E2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C5C92DC7-468D-4F9F-8A3E-34642BA9AB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B8A694F8-B38E-4491-87B7-58DC14D1C8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8BD4B-DD93-4BBA-90B8-A2EDFD22F519}" type="datetimeFigureOut">
              <a:rPr lang="da-DK" smtClean="0"/>
              <a:t>08-09-2022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B76D3334-3C30-476A-BAB5-35E4680C1D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F0A60C4A-4E86-4CD2-9A69-813103149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58537B-85A7-45F3-B6A5-2825FFF8283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461152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202A839-C3B1-4368-A601-D40984DCCF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AA4D716D-C2F5-4243-8353-535F22FB9A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95717E8D-57CF-498B-95CE-2979A42825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19958BA8-EFAC-486C-9BB8-665CACCA33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8BD4B-DD93-4BBA-90B8-A2EDFD22F519}" type="datetimeFigureOut">
              <a:rPr lang="da-DK" smtClean="0"/>
              <a:t>08-09-2022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5F312370-2716-4497-B398-CCA204C907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296193AE-7DA7-4722-A3CA-A41C8AE52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58537B-85A7-45F3-B6A5-2825FFF8283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862393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949DBB3-E229-43E2-8EDB-B46FF0353D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15537DDD-7E5B-4D68-9FFF-05EFA024BF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91B1E8D3-74F5-43EB-A7F3-68D773EFCF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tekst 4">
            <a:extLst>
              <a:ext uri="{FF2B5EF4-FFF2-40B4-BE49-F238E27FC236}">
                <a16:creationId xmlns:a16="http://schemas.microsoft.com/office/drawing/2014/main" id="{ECA764FD-98E1-40ED-8C28-AB6391396F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Pladsholder til indhold 5">
            <a:extLst>
              <a:ext uri="{FF2B5EF4-FFF2-40B4-BE49-F238E27FC236}">
                <a16:creationId xmlns:a16="http://schemas.microsoft.com/office/drawing/2014/main" id="{903F83FF-59AA-44BB-A8AA-47E28888EB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7" name="Pladsholder til dato 6">
            <a:extLst>
              <a:ext uri="{FF2B5EF4-FFF2-40B4-BE49-F238E27FC236}">
                <a16:creationId xmlns:a16="http://schemas.microsoft.com/office/drawing/2014/main" id="{224234E2-93B4-4C1D-8271-BED512247A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8BD4B-DD93-4BBA-90B8-A2EDFD22F519}" type="datetimeFigureOut">
              <a:rPr lang="da-DK" smtClean="0"/>
              <a:t>08-09-2022</a:t>
            </a:fld>
            <a:endParaRPr lang="da-DK"/>
          </a:p>
        </p:txBody>
      </p:sp>
      <p:sp>
        <p:nvSpPr>
          <p:cNvPr id="8" name="Pladsholder til sidefod 7">
            <a:extLst>
              <a:ext uri="{FF2B5EF4-FFF2-40B4-BE49-F238E27FC236}">
                <a16:creationId xmlns:a16="http://schemas.microsoft.com/office/drawing/2014/main" id="{886D29C6-DFFF-494E-86B6-2B21A28014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slidenummer 8">
            <a:extLst>
              <a:ext uri="{FF2B5EF4-FFF2-40B4-BE49-F238E27FC236}">
                <a16:creationId xmlns:a16="http://schemas.microsoft.com/office/drawing/2014/main" id="{CFE539E1-57A6-44A6-86B2-ACAC71FED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58537B-85A7-45F3-B6A5-2825FFF8283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0470057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0650F46-8129-4EF7-81F3-235DCD2108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dato 2">
            <a:extLst>
              <a:ext uri="{FF2B5EF4-FFF2-40B4-BE49-F238E27FC236}">
                <a16:creationId xmlns:a16="http://schemas.microsoft.com/office/drawing/2014/main" id="{9BB9F7BD-638C-4A3C-8B68-F9D2C1686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8BD4B-DD93-4BBA-90B8-A2EDFD22F519}" type="datetimeFigureOut">
              <a:rPr lang="da-DK" smtClean="0"/>
              <a:t>08-09-2022</a:t>
            </a:fld>
            <a:endParaRPr lang="da-DK"/>
          </a:p>
        </p:txBody>
      </p:sp>
      <p:sp>
        <p:nvSpPr>
          <p:cNvPr id="4" name="Pladsholder til sidefod 3">
            <a:extLst>
              <a:ext uri="{FF2B5EF4-FFF2-40B4-BE49-F238E27FC236}">
                <a16:creationId xmlns:a16="http://schemas.microsoft.com/office/drawing/2014/main" id="{65042978-40E7-4023-9C19-5E1978D5C3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slidenummer 4">
            <a:extLst>
              <a:ext uri="{FF2B5EF4-FFF2-40B4-BE49-F238E27FC236}">
                <a16:creationId xmlns:a16="http://schemas.microsoft.com/office/drawing/2014/main" id="{AAD139E9-4233-4051-88AA-6F0450DD57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58537B-85A7-45F3-B6A5-2825FFF8283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460833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>
            <a:extLst>
              <a:ext uri="{FF2B5EF4-FFF2-40B4-BE49-F238E27FC236}">
                <a16:creationId xmlns:a16="http://schemas.microsoft.com/office/drawing/2014/main" id="{6612AD39-B722-4D58-89AB-15D61A01D1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8BD4B-DD93-4BBA-90B8-A2EDFD22F519}" type="datetimeFigureOut">
              <a:rPr lang="da-DK" smtClean="0"/>
              <a:t>08-09-2022</a:t>
            </a:fld>
            <a:endParaRPr lang="da-DK"/>
          </a:p>
        </p:txBody>
      </p:sp>
      <p:sp>
        <p:nvSpPr>
          <p:cNvPr id="3" name="Pladsholder til sidefod 2">
            <a:extLst>
              <a:ext uri="{FF2B5EF4-FFF2-40B4-BE49-F238E27FC236}">
                <a16:creationId xmlns:a16="http://schemas.microsoft.com/office/drawing/2014/main" id="{1337AE02-5F8D-4123-B2EC-1BA915BF6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>
            <a:extLst>
              <a:ext uri="{FF2B5EF4-FFF2-40B4-BE49-F238E27FC236}">
                <a16:creationId xmlns:a16="http://schemas.microsoft.com/office/drawing/2014/main" id="{90B97966-BCC0-45FB-B4FF-C92BB86CF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58537B-85A7-45F3-B6A5-2825FFF8283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5850917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09F8D98-1154-4CA9-B370-CAC5AF760B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5945651A-1F8F-4366-9497-C163CF8A03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A0D1BE29-A523-415B-AC3E-9A48992D53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918A5146-F765-42E7-857E-CBE9E1817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8BD4B-DD93-4BBA-90B8-A2EDFD22F519}" type="datetimeFigureOut">
              <a:rPr lang="da-DK" smtClean="0"/>
              <a:t>08-09-2022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7F8D79E9-9ED4-430C-8E20-448D684E6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57B94FDD-AC7D-4D59-A254-77CDB46B9A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58537B-85A7-45F3-B6A5-2825FFF8283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633012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4C0CD36-9A0E-43BE-9C65-62C86E391C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billede 2">
            <a:extLst>
              <a:ext uri="{FF2B5EF4-FFF2-40B4-BE49-F238E27FC236}">
                <a16:creationId xmlns:a16="http://schemas.microsoft.com/office/drawing/2014/main" id="{23B82BE4-9971-41CF-A5FF-646155A6EA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BD691618-97CC-4A6E-B680-6249DD25B4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CB9D46A9-7899-41E6-BE0F-DE760318E0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8BD4B-DD93-4BBA-90B8-A2EDFD22F519}" type="datetimeFigureOut">
              <a:rPr lang="da-DK" smtClean="0"/>
              <a:t>08-09-2022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FE66C174-86D6-42F9-9A57-91C708C91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CDF32398-A45C-41AE-B886-E9B815F0C7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58537B-85A7-45F3-B6A5-2825FFF8283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690019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>
            <a:extLst>
              <a:ext uri="{FF2B5EF4-FFF2-40B4-BE49-F238E27FC236}">
                <a16:creationId xmlns:a16="http://schemas.microsoft.com/office/drawing/2014/main" id="{7BAB8265-C612-4A72-8C35-EC18EE8FD8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E499C5E1-ED79-4058-940C-65F2742CC8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6A440018-5D59-4C95-9B57-D78EFD2A92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D8BD4B-DD93-4BBA-90B8-A2EDFD22F519}" type="datetimeFigureOut">
              <a:rPr lang="da-DK" smtClean="0"/>
              <a:t>08-09-2022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CEC1F18F-28EC-429D-90E6-F08AD840A6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02680D10-9FEA-42F1-B4F8-AF662F2EFD0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58537B-85A7-45F3-B6A5-2825FFF8283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781147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 4">
            <a:extLst>
              <a:ext uri="{FF2B5EF4-FFF2-40B4-BE49-F238E27FC236}">
                <a16:creationId xmlns:a16="http://schemas.microsoft.com/office/drawing/2014/main" id="{254EB14C-B1FE-4F32-9755-B0D622DE4C2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6308466"/>
              </p:ext>
            </p:extLst>
          </p:nvPr>
        </p:nvGraphicFramePr>
        <p:xfrm>
          <a:off x="782431" y="835444"/>
          <a:ext cx="10776703" cy="544676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72551">
                  <a:extLst>
                    <a:ext uri="{9D8B030D-6E8A-4147-A177-3AD203B41FA5}">
                      <a16:colId xmlns:a16="http://schemas.microsoft.com/office/drawing/2014/main" val="3378136997"/>
                    </a:ext>
                  </a:extLst>
                </a:gridCol>
                <a:gridCol w="4704152">
                  <a:extLst>
                    <a:ext uri="{9D8B030D-6E8A-4147-A177-3AD203B41FA5}">
                      <a16:colId xmlns:a16="http://schemas.microsoft.com/office/drawing/2014/main" val="1559362965"/>
                    </a:ext>
                  </a:extLst>
                </a:gridCol>
              </a:tblGrid>
              <a:tr h="301249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u="none" strike="noStrike" dirty="0">
                          <a:effectLst/>
                        </a:rPr>
                        <a:t>Sex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2000" u="none" strike="noStrike" dirty="0">
                          <a:effectLst/>
                        </a:rPr>
                        <a:t>Female n= 4, Male n=5</a:t>
                      </a:r>
                      <a:endParaRPr lang="pt-BR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5079754"/>
                  </a:ext>
                </a:extLst>
              </a:tr>
              <a:tr h="342067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u="none" strike="noStrike" dirty="0">
                          <a:effectLst/>
                        </a:rPr>
                        <a:t>Age at inclusion in years, median (min-max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u="none" strike="noStrike" dirty="0">
                          <a:effectLst/>
                        </a:rPr>
                        <a:t>57 (46-72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51205038"/>
                  </a:ext>
                </a:extLst>
              </a:tr>
              <a:tr h="36781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u="none" strike="noStrike" dirty="0">
                          <a:effectLst/>
                        </a:rPr>
                        <a:t>Duration of disease in years, median (min-max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u="none" strike="noStrike" dirty="0">
                          <a:effectLst/>
                        </a:rPr>
                        <a:t>6.5 (2-26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40600500"/>
                  </a:ext>
                </a:extLst>
              </a:tr>
              <a:tr h="509080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u="none" strike="noStrike" dirty="0">
                          <a:effectLst/>
                        </a:rPr>
                        <a:t>Diagnosis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2000" u="none" strike="noStrike" dirty="0">
                          <a:effectLst/>
                        </a:rPr>
                        <a:t>ET n=7 </a:t>
                      </a:r>
                    </a:p>
                    <a:p>
                      <a:pPr algn="l" fontAlgn="b"/>
                      <a:r>
                        <a:rPr lang="pt-BR" sz="2000" u="none" strike="noStrike" dirty="0">
                          <a:effectLst/>
                        </a:rPr>
                        <a:t>PV n=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14714631"/>
                  </a:ext>
                </a:extLst>
              </a:tr>
              <a:tr h="989421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u="none" strike="noStrike" dirty="0">
                          <a:effectLst/>
                        </a:rPr>
                        <a:t>Treatment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2000" u="none" strike="noStrike" dirty="0">
                          <a:effectLst/>
                        </a:rPr>
                        <a:t>Pegylated Interferon-alpha n=5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2000" u="none" strike="noStrike" dirty="0">
                          <a:effectLst/>
                        </a:rPr>
                        <a:t>No Treatment n=2</a:t>
                      </a:r>
                      <a:endParaRPr lang="pt-BR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r>
                        <a:rPr lang="pt-BR" sz="2000" u="none" strike="noStrike" dirty="0">
                          <a:effectLst/>
                        </a:rPr>
                        <a:t>Anagrelide n=1</a:t>
                      </a:r>
                    </a:p>
                    <a:p>
                      <a:pPr algn="l" fontAlgn="b"/>
                      <a:r>
                        <a:rPr lang="pt-BR" sz="2000" u="none" strike="noStrike" dirty="0">
                          <a:effectLst/>
                        </a:rPr>
                        <a:t>Phlebotomy n=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95276609"/>
                  </a:ext>
                </a:extLst>
              </a:tr>
              <a:tr h="36781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telet count at inclusion, median (min-max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9x10</a:t>
                      </a:r>
                      <a:r>
                        <a:rPr lang="da-DK" sz="2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  <a:r>
                        <a:rPr lang="da-DK" sz="20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/l  (219x</a:t>
                      </a:r>
                      <a:r>
                        <a:rPr lang="da-DK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  <a:r>
                        <a:rPr lang="da-DK" sz="2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  <a:r>
                        <a:rPr lang="da-DK" sz="20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/l – 630x</a:t>
                      </a:r>
                      <a:r>
                        <a:rPr lang="da-DK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  <a:r>
                        <a:rPr lang="da-DK" sz="2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  <a:r>
                        <a:rPr lang="da-DK" sz="20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/l 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63505608"/>
                  </a:ext>
                </a:extLst>
              </a:tr>
              <a:tr h="36781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moglobin at inclusion, median (min-max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,6 mmol/l (7,8mmol/l – 9,7mmol/l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46622743"/>
                  </a:ext>
                </a:extLst>
              </a:tr>
              <a:tr h="36781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ukocyte count at inclusion, median (min-max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,2x10</a:t>
                      </a:r>
                      <a:r>
                        <a:rPr lang="da-DK" sz="2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  <a:r>
                        <a:rPr lang="da-DK" sz="20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/l (3,5x</a:t>
                      </a:r>
                      <a:r>
                        <a:rPr lang="da-DK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  <a:r>
                        <a:rPr lang="da-DK" sz="2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  <a:r>
                        <a:rPr lang="da-DK" sz="20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/l – 8,2x</a:t>
                      </a:r>
                      <a:r>
                        <a:rPr lang="da-DK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  <a:r>
                        <a:rPr lang="da-DK" sz="2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  <a:r>
                        <a:rPr lang="da-DK" sz="20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/l) 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77054432"/>
                  </a:ext>
                </a:extLst>
              </a:tr>
              <a:tr h="36781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tate dehydrogenase, median (min-max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9 U/mL (172 U/mL  - 224 U/mL)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94448238"/>
                  </a:ext>
                </a:extLst>
              </a:tr>
              <a:tr h="36781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ythrocyte volume fraction, median (min-max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 % (39 % - 46 %)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91668306"/>
                  </a:ext>
                </a:extLst>
              </a:tr>
              <a:tr h="36781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PN driver mutatio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i="1" u="none" strike="noStrike" dirty="0">
                          <a:effectLst/>
                        </a:rPr>
                        <a:t>JAK2</a:t>
                      </a:r>
                      <a:r>
                        <a:rPr lang="en-US" sz="2000" i="0" u="none" strike="noStrike" dirty="0">
                          <a:effectLst/>
                        </a:rPr>
                        <a:t>V617F</a:t>
                      </a:r>
                      <a:r>
                        <a:rPr lang="en-US" sz="2000" i="1" u="none" strike="noStrike" dirty="0">
                          <a:effectLst/>
                        </a:rPr>
                        <a:t> </a:t>
                      </a:r>
                      <a:r>
                        <a:rPr lang="en-US" sz="2000" i="0" u="none" strike="noStrike" dirty="0">
                          <a:effectLst/>
                        </a:rPr>
                        <a:t>n=9</a:t>
                      </a:r>
                      <a:endParaRPr lang="en-US" sz="2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67770062"/>
                  </a:ext>
                </a:extLst>
              </a:tr>
              <a:tr h="367815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</a:t>
                      </a:r>
                      <a:r>
                        <a:rPr lang="en-US" sz="2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AK2</a:t>
                      </a:r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617F VAF at inclusion, median (min-max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u="none" strike="noStrike" dirty="0">
                          <a:effectLst/>
                        </a:rPr>
                        <a:t>12,81% (1,36% - 32,58%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7574109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55252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92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æ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Morten Orebo Holmström</dc:creator>
  <cp:lastModifiedBy>Morten Orebo Holmström</cp:lastModifiedBy>
  <cp:revision>5</cp:revision>
  <dcterms:created xsi:type="dcterms:W3CDTF">2020-11-10T16:21:05Z</dcterms:created>
  <dcterms:modified xsi:type="dcterms:W3CDTF">2022-09-08T12:31:40Z</dcterms:modified>
</cp:coreProperties>
</file>